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60" r:id="rId3"/>
    <p:sldId id="257" r:id="rId4"/>
    <p:sldId id="261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/>
    <p:restoredTop sz="94609"/>
  </p:normalViewPr>
  <p:slideViewPr>
    <p:cSldViewPr snapToGrid="0" snapToObjects="1">
      <p:cViewPr varScale="1">
        <p:scale>
          <a:sx n="85" d="100"/>
          <a:sy n="85" d="100"/>
        </p:scale>
        <p:origin x="34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8EA6F81-28DB-A74C-8674-2BF384602A6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3E8158F-69FF-D146-B1A0-F6672D0100A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8E90CD2-2FCF-A045-8455-073DB01CEC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6C281-0CCE-B044-BC88-4DC12A45BA1F}" type="datetimeFigureOut">
              <a:rPr kumimoji="1" lang="zh-CN" altLang="en-US" smtClean="0"/>
              <a:t>2021/7/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714594F-FEBC-4948-82F1-821F8716A1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F59ECC0-15AF-AA42-B8C4-FD61E1BF7F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9619E-4FA3-AB47-80E3-5F7E2A7AC1D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060634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313B6C4-B6FB-BE41-8C80-6D583DE105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18AE6C0-DB68-5A40-AE0B-F826F48A09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D039B15-D99C-3D4D-981E-31D806EB7C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6C281-0CCE-B044-BC88-4DC12A45BA1F}" type="datetimeFigureOut">
              <a:rPr kumimoji="1" lang="zh-CN" altLang="en-US" smtClean="0"/>
              <a:t>2021/7/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F296DA0-28A4-DE47-82B0-EE640862E5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AA5AB84-C60E-3444-B838-8D80618B2C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9619E-4FA3-AB47-80E3-5F7E2A7AC1D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320095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E2769D7-2DC5-0542-A666-8581916642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5196BC0-414C-BD43-A478-6ACA4367D3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EC76D6B-BA12-9E4F-8812-A146DBA06E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6C281-0CCE-B044-BC88-4DC12A45BA1F}" type="datetimeFigureOut">
              <a:rPr kumimoji="1" lang="zh-CN" altLang="en-US" smtClean="0"/>
              <a:t>2021/7/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4564AEF-D931-D548-8B6C-51C9243C92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0F5BC5E-6606-B244-A023-0A684E42AF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9619E-4FA3-AB47-80E3-5F7E2A7AC1D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334228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25AF2E0-0081-7B4C-BC64-F7F7D4578A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64A7B59-6706-AB43-AED0-8941DF77F95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707CD9D-0E74-634A-8A28-20096F0C72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6C281-0CCE-B044-BC88-4DC12A45BA1F}" type="datetimeFigureOut">
              <a:rPr kumimoji="1" lang="zh-CN" altLang="en-US" smtClean="0"/>
              <a:t>2021/7/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E0C62F7-FF68-5F4C-8EC3-7463B25E64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09C8705-E79A-D742-93BD-BCDB57E08B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9619E-4FA3-AB47-80E3-5F7E2A7AC1D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811746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7B35057-9D2F-EF46-87DC-49B33A7F4E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8E657FA-2038-2A4D-8F82-210040FA2D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46CE405-9821-0643-AE13-8C264716E0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6C281-0CCE-B044-BC88-4DC12A45BA1F}" type="datetimeFigureOut">
              <a:rPr kumimoji="1" lang="zh-CN" altLang="en-US" smtClean="0"/>
              <a:t>2021/7/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183D87C-0244-E444-82BC-2740B68573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B843B97-FFC3-F842-A8B9-A906462336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9619E-4FA3-AB47-80E3-5F7E2A7AC1D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287696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0F0AC9F-CD67-4946-8116-B6C4BF2965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8A6E7B8-9501-C345-90CB-EDE9078268B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D9263A6-E005-214D-A5B6-A10D1DCE8B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8CD5DBB-0C0B-0E4B-B13D-10254020CB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6C281-0CCE-B044-BC88-4DC12A45BA1F}" type="datetimeFigureOut">
              <a:rPr kumimoji="1" lang="zh-CN" altLang="en-US" smtClean="0"/>
              <a:t>2021/7/7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37CA2E6-63EF-8749-8A3D-39A1510166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947E380-3E86-E144-A66B-A98A96811C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9619E-4FA3-AB47-80E3-5F7E2A7AC1D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573407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E67B58B-39D7-514D-928F-BF193B2D47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28DCB3F-EBB5-784A-9A23-7E31FD812E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75B72ED-A218-1B40-A988-47DAF67402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0DF4DCAB-54F8-104C-A61C-32974035FAF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B6FF08A-4113-CB43-9454-33FF0360AB4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4CE17B9-71A9-2C40-8E9C-EBDA504B9A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6C281-0CCE-B044-BC88-4DC12A45BA1F}" type="datetimeFigureOut">
              <a:rPr kumimoji="1" lang="zh-CN" altLang="en-US" smtClean="0"/>
              <a:t>2021/7/7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2A19B32-A121-AC47-A2F7-4741D45EE4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74D68F82-74FC-0243-806E-BDB7046CA5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9619E-4FA3-AB47-80E3-5F7E2A7AC1D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391882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A1FC0C9-202B-034C-A8A8-E3151F2509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F4F49C2B-9DFB-5D49-BD00-811A40A7D7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6C281-0CCE-B044-BC88-4DC12A45BA1F}" type="datetimeFigureOut">
              <a:rPr kumimoji="1" lang="zh-CN" altLang="en-US" smtClean="0"/>
              <a:t>2021/7/7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C64F18E-ED5E-1049-B00D-3198783005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D0ACA34-78A4-B540-AD42-1346FD206B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9619E-4FA3-AB47-80E3-5F7E2A7AC1D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376695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D2FDB47-D404-FC4A-9BBD-22BB5F537A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6C281-0CCE-B044-BC88-4DC12A45BA1F}" type="datetimeFigureOut">
              <a:rPr kumimoji="1" lang="zh-CN" altLang="en-US" smtClean="0"/>
              <a:t>2021/7/7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AD6E6F8-6618-2B42-B83E-C83DAB6968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AA6771BC-D263-C447-8147-635CBE5BA7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9619E-4FA3-AB47-80E3-5F7E2A7AC1D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492871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ECDB65C-7928-9C46-BCA3-4E121B0820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E0FE16A-8E06-184A-80CA-4CC3D3720D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7F733C0-5678-5248-923D-255A4E17443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7BA3315-D6ED-3C4F-939C-2DFC117587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6C281-0CCE-B044-BC88-4DC12A45BA1F}" type="datetimeFigureOut">
              <a:rPr kumimoji="1" lang="zh-CN" altLang="en-US" smtClean="0"/>
              <a:t>2021/7/7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6776BD6-A0D1-AB46-ABCD-7C545B32BA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B071E32-9620-764C-ABA4-05B3846553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9619E-4FA3-AB47-80E3-5F7E2A7AC1D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914339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9276E5D-8C51-374B-B5AC-F48E686CC8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BE9F835-FBA6-774A-8897-BF3582EC7CF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DCE1A24-DC75-FD47-A61F-DAD89F2276A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B85999A-D34B-2640-8665-F09CF190AB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6C281-0CCE-B044-BC88-4DC12A45BA1F}" type="datetimeFigureOut">
              <a:rPr kumimoji="1" lang="zh-CN" altLang="en-US" smtClean="0"/>
              <a:t>2021/7/7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B525353-C255-F043-A759-3C3C3220F8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D318F1F-9BB7-2743-BD3F-65A282A660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9619E-4FA3-AB47-80E3-5F7E2A7AC1D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601753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1F87E595-7342-334A-B509-D3409B1A80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CA968D0-BF30-DE44-B675-B36A79829A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4EE25B-B6E9-5440-AF56-18A3BCF8440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36C281-0CCE-B044-BC88-4DC12A45BA1F}" type="datetimeFigureOut">
              <a:rPr kumimoji="1" lang="zh-CN" altLang="en-US" smtClean="0"/>
              <a:t>2021/7/7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B605C11-F840-0C4E-90C4-C05ACD30789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47BB30B-3401-D74F-8575-525208D4632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E9619E-4FA3-AB47-80E3-5F7E2A7AC1D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105272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 descr="图片包含 图表&#10;&#10;描述已自动生成">
            <a:extLst>
              <a:ext uri="{FF2B5EF4-FFF2-40B4-BE49-F238E27FC236}">
                <a16:creationId xmlns:a16="http://schemas.microsoft.com/office/drawing/2014/main" id="{E82AF419-04DA-4441-AD9F-8D0E6BD2D37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26350" y="997466"/>
            <a:ext cx="2425700" cy="5232400"/>
          </a:xfrm>
          <a:prstGeom prst="rect">
            <a:avLst/>
          </a:prstGeom>
        </p:spPr>
      </p:pic>
      <p:pic>
        <p:nvPicPr>
          <p:cNvPr id="9" name="图片 8" descr="图片包含 图表&#10;&#10;描述已自动生成">
            <a:extLst>
              <a:ext uri="{FF2B5EF4-FFF2-40B4-BE49-F238E27FC236}">
                <a16:creationId xmlns:a16="http://schemas.microsoft.com/office/drawing/2014/main" id="{A64649A7-99FD-244E-BC1D-5E1FBDE4905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59765" y="984766"/>
            <a:ext cx="2425700" cy="5245100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B9ED2ACD-66D5-BB43-B6A3-B3D1A264ED20}"/>
              </a:ext>
            </a:extLst>
          </p:cNvPr>
          <p:cNvSpPr txBox="1"/>
          <p:nvPr/>
        </p:nvSpPr>
        <p:spPr>
          <a:xfrm>
            <a:off x="0" y="66222"/>
            <a:ext cx="102954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Representative dot plots shown and processed dot plot outputs showing gate for  S18 cell </a:t>
            </a:r>
            <a:endParaRPr kumimoji="1"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36E8DFBE-AC54-8A4F-8A40-FD0D287F28D2}"/>
              </a:ext>
            </a:extLst>
          </p:cNvPr>
          <p:cNvSpPr txBox="1"/>
          <p:nvPr/>
        </p:nvSpPr>
        <p:spPr>
          <a:xfrm>
            <a:off x="2649766" y="582260"/>
            <a:ext cx="13117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Blank</a:t>
            </a:r>
            <a:endParaRPr kumimoji="1"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5F9B4DAC-4AE0-B247-8ECC-D336B1BA45EE}"/>
              </a:ext>
            </a:extLst>
          </p:cNvPr>
          <p:cNvSpPr txBox="1"/>
          <p:nvPr/>
        </p:nvSpPr>
        <p:spPr>
          <a:xfrm>
            <a:off x="5384396" y="582260"/>
            <a:ext cx="9942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S18 </a:t>
            </a:r>
            <a:r>
              <a:rPr kumimoji="1" lang="en-US" altLang="zh-CN" dirty="0" err="1"/>
              <a:t>vec</a:t>
            </a:r>
            <a:endParaRPr kumimoji="1"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FF347F1C-828F-FA43-903E-C3B8D7ED5AD7}"/>
              </a:ext>
            </a:extLst>
          </p:cNvPr>
          <p:cNvSpPr txBox="1"/>
          <p:nvPr/>
        </p:nvSpPr>
        <p:spPr>
          <a:xfrm>
            <a:off x="8128452" y="628134"/>
            <a:ext cx="14214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S18 NKILA</a:t>
            </a:r>
            <a:endParaRPr kumimoji="1" lang="zh-CN" altLang="en-US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E276EBBF-9AAD-4D66-B385-2D6C050851A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80480" y="991116"/>
            <a:ext cx="2438400" cy="52387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905241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B9ED2ACD-66D5-BB43-B6A3-B3D1A264ED20}"/>
              </a:ext>
            </a:extLst>
          </p:cNvPr>
          <p:cNvSpPr txBox="1"/>
          <p:nvPr/>
        </p:nvSpPr>
        <p:spPr>
          <a:xfrm>
            <a:off x="0" y="66222"/>
            <a:ext cx="46300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Replicate dot plots for S18 cell </a:t>
            </a:r>
            <a:endParaRPr kumimoji="1"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5F9B4DAC-4AE0-B247-8ECC-D336B1BA45EE}"/>
              </a:ext>
            </a:extLst>
          </p:cNvPr>
          <p:cNvSpPr txBox="1"/>
          <p:nvPr/>
        </p:nvSpPr>
        <p:spPr>
          <a:xfrm>
            <a:off x="3961470" y="435554"/>
            <a:ext cx="9942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S18 </a:t>
            </a:r>
            <a:r>
              <a:rPr kumimoji="1" lang="en-US" altLang="zh-CN" dirty="0" err="1"/>
              <a:t>vec</a:t>
            </a:r>
            <a:endParaRPr kumimoji="1"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FF347F1C-828F-FA43-903E-C3B8D7ED5AD7}"/>
              </a:ext>
            </a:extLst>
          </p:cNvPr>
          <p:cNvSpPr txBox="1"/>
          <p:nvPr/>
        </p:nvSpPr>
        <p:spPr>
          <a:xfrm>
            <a:off x="6558038" y="435554"/>
            <a:ext cx="14214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S18 NKILA</a:t>
            </a:r>
            <a:endParaRPr kumimoji="1" lang="zh-CN" altLang="en-US" dirty="0"/>
          </a:p>
        </p:txBody>
      </p:sp>
      <p:pic>
        <p:nvPicPr>
          <p:cNvPr id="24" name="图片 23">
            <a:extLst>
              <a:ext uri="{FF2B5EF4-FFF2-40B4-BE49-F238E27FC236}">
                <a16:creationId xmlns:a16="http://schemas.microsoft.com/office/drawing/2014/main" id="{E53625C7-E60C-423B-B3D0-D946A3D4023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28698" y="828675"/>
            <a:ext cx="2419350" cy="2600325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4CC9D9BE-0C55-41DE-88EB-BF6D10AE400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44148" y="819150"/>
            <a:ext cx="2428875" cy="2609850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DA13E310-14C7-479C-AB3F-D167491462C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44148" y="3564232"/>
            <a:ext cx="2419350" cy="2600325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749A0037-26F3-42BC-ABB9-FD6443D1ADD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19395" y="3564232"/>
            <a:ext cx="2400300" cy="2619375"/>
          </a:xfrm>
          <a:prstGeom prst="rect">
            <a:avLst/>
          </a:prstGeom>
        </p:spPr>
      </p:pic>
      <p:sp>
        <p:nvSpPr>
          <p:cNvPr id="32" name="文本框 31">
            <a:extLst>
              <a:ext uri="{FF2B5EF4-FFF2-40B4-BE49-F238E27FC236}">
                <a16:creationId xmlns:a16="http://schemas.microsoft.com/office/drawing/2014/main" id="{DD981732-1DCF-4C12-B771-F0F76BB682E1}"/>
              </a:ext>
            </a:extLst>
          </p:cNvPr>
          <p:cNvSpPr txBox="1"/>
          <p:nvPr/>
        </p:nvSpPr>
        <p:spPr>
          <a:xfrm>
            <a:off x="1275907" y="1939409"/>
            <a:ext cx="146729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zh-CN" dirty="0"/>
              <a:t>Replicate-1</a:t>
            </a:r>
            <a:endParaRPr lang="zh-CN" altLang="en-US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D7F8BD9E-0593-4F3C-A170-160CD09D97BE}"/>
              </a:ext>
            </a:extLst>
          </p:cNvPr>
          <p:cNvSpPr txBox="1"/>
          <p:nvPr/>
        </p:nvSpPr>
        <p:spPr>
          <a:xfrm>
            <a:off x="1275907" y="4679728"/>
            <a:ext cx="146729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zh-CN" dirty="0"/>
              <a:t>Replicate-2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650017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B9ED2ACD-66D5-BB43-B6A3-B3D1A264ED20}"/>
              </a:ext>
            </a:extLst>
          </p:cNvPr>
          <p:cNvSpPr txBox="1"/>
          <p:nvPr/>
        </p:nvSpPr>
        <p:spPr>
          <a:xfrm>
            <a:off x="0" y="66222"/>
            <a:ext cx="10114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Representative dot plots shown and processed dot plot outputs showing gate for S26 cells </a:t>
            </a:r>
            <a:endParaRPr kumimoji="1"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36E8DFBE-AC54-8A4F-8A40-FD0D287F28D2}"/>
              </a:ext>
            </a:extLst>
          </p:cNvPr>
          <p:cNvSpPr txBox="1"/>
          <p:nvPr/>
        </p:nvSpPr>
        <p:spPr>
          <a:xfrm>
            <a:off x="1579636" y="538194"/>
            <a:ext cx="9942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Blank</a:t>
            </a:r>
            <a:endParaRPr kumimoji="1"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5F9B4DAC-4AE0-B247-8ECC-D336B1BA45EE}"/>
              </a:ext>
            </a:extLst>
          </p:cNvPr>
          <p:cNvSpPr txBox="1"/>
          <p:nvPr/>
        </p:nvSpPr>
        <p:spPr>
          <a:xfrm>
            <a:off x="3922484" y="538194"/>
            <a:ext cx="1219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S26 </a:t>
            </a:r>
            <a:r>
              <a:rPr kumimoji="1" lang="en-US" altLang="zh-CN" dirty="0" err="1"/>
              <a:t>shGFP</a:t>
            </a:r>
            <a:endParaRPr kumimoji="1"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FF347F1C-828F-FA43-903E-C3B8D7ED5AD7}"/>
              </a:ext>
            </a:extLst>
          </p:cNvPr>
          <p:cNvSpPr txBox="1"/>
          <p:nvPr/>
        </p:nvSpPr>
        <p:spPr>
          <a:xfrm>
            <a:off x="6490707" y="538194"/>
            <a:ext cx="14214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S26 shNK1</a:t>
            </a:r>
            <a:endParaRPr kumimoji="1" lang="zh-CN" altLang="en-US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5ADF6F5A-8982-405C-AAD5-236FF3BAB10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0382" y="1010166"/>
            <a:ext cx="2419350" cy="5219700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16866131-4AAE-473B-B604-2CF8713B3F6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64163" y="997466"/>
            <a:ext cx="2447925" cy="5229225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4C18140E-0455-41C0-9EB8-32E04B3D489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536519" y="997465"/>
            <a:ext cx="2428875" cy="5229225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E30D7FB7-5CD2-4A3B-B8E0-4F56C7112A63}"/>
              </a:ext>
            </a:extLst>
          </p:cNvPr>
          <p:cNvSpPr txBox="1"/>
          <p:nvPr/>
        </p:nvSpPr>
        <p:spPr>
          <a:xfrm>
            <a:off x="9190868" y="540166"/>
            <a:ext cx="14214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S26 shNK2</a:t>
            </a:r>
            <a:endParaRPr kumimoji="1"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21EAAFF3-02DA-4DA7-8114-D6E5E99C3BE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44903" y="1005403"/>
            <a:ext cx="2428875" cy="52292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93653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B9ED2ACD-66D5-BB43-B6A3-B3D1A264ED20}"/>
              </a:ext>
            </a:extLst>
          </p:cNvPr>
          <p:cNvSpPr txBox="1"/>
          <p:nvPr/>
        </p:nvSpPr>
        <p:spPr>
          <a:xfrm>
            <a:off x="0" y="66222"/>
            <a:ext cx="46300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Replicate dot plots for S26 cells</a:t>
            </a:r>
            <a:endParaRPr kumimoji="1"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5F9B4DAC-4AE0-B247-8ECC-D336B1BA45EE}"/>
              </a:ext>
            </a:extLst>
          </p:cNvPr>
          <p:cNvSpPr txBox="1"/>
          <p:nvPr/>
        </p:nvSpPr>
        <p:spPr>
          <a:xfrm>
            <a:off x="3743075" y="447448"/>
            <a:ext cx="14214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S26 </a:t>
            </a:r>
            <a:r>
              <a:rPr kumimoji="1" lang="en-US" altLang="zh-CN" dirty="0" err="1"/>
              <a:t>shGFP</a:t>
            </a:r>
            <a:endParaRPr kumimoji="1"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FF347F1C-828F-FA43-903E-C3B8D7ED5AD7}"/>
              </a:ext>
            </a:extLst>
          </p:cNvPr>
          <p:cNvSpPr txBox="1"/>
          <p:nvPr/>
        </p:nvSpPr>
        <p:spPr>
          <a:xfrm>
            <a:off x="6378675" y="457123"/>
            <a:ext cx="14214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S26 shNK1</a:t>
            </a:r>
            <a:endParaRPr kumimoji="1" lang="zh-CN" altLang="en-US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DD981732-1DCF-4C12-B771-F0F76BB682E1}"/>
              </a:ext>
            </a:extLst>
          </p:cNvPr>
          <p:cNvSpPr txBox="1"/>
          <p:nvPr/>
        </p:nvSpPr>
        <p:spPr>
          <a:xfrm>
            <a:off x="1275907" y="1939409"/>
            <a:ext cx="146729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zh-CN" dirty="0"/>
              <a:t>Replicate-1</a:t>
            </a:r>
            <a:endParaRPr lang="zh-CN" altLang="en-US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D7F8BD9E-0593-4F3C-A170-160CD09D97BE}"/>
              </a:ext>
            </a:extLst>
          </p:cNvPr>
          <p:cNvSpPr txBox="1"/>
          <p:nvPr/>
        </p:nvSpPr>
        <p:spPr>
          <a:xfrm>
            <a:off x="1275907" y="4679728"/>
            <a:ext cx="146729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zh-CN" dirty="0"/>
              <a:t>Replicate-2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17B998DE-2D31-4859-80D0-FAB3DDDF7F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44148" y="828675"/>
            <a:ext cx="2419350" cy="2600325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8CA0654E-2C7B-4330-865D-9B60A1F31E2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84510" y="823912"/>
            <a:ext cx="2409825" cy="2600325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892F322B-55DF-4120-B359-83569509290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515347" y="808590"/>
            <a:ext cx="2409825" cy="2600325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300CF981-F3EC-4B9E-A299-5C52C22DDD0E}"/>
              </a:ext>
            </a:extLst>
          </p:cNvPr>
          <p:cNvSpPr txBox="1"/>
          <p:nvPr/>
        </p:nvSpPr>
        <p:spPr>
          <a:xfrm>
            <a:off x="9012180" y="459343"/>
            <a:ext cx="14214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/>
              <a:t>S26 shNK2</a:t>
            </a:r>
            <a:endParaRPr kumimoji="1" lang="zh-CN" altLang="en-US" dirty="0"/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AAC3E94C-4F5D-43EE-AC74-C0CCA2FC8DF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63198" y="3564231"/>
            <a:ext cx="2400300" cy="2600325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B6A0DFD8-62BB-48B4-B938-D6666C18746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884510" y="3572933"/>
            <a:ext cx="2419350" cy="2609850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2C31DAF8-3D2B-4CF5-B86B-4F6C65ECE06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506268" y="3572933"/>
            <a:ext cx="2409825" cy="26003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321369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7</TotalTime>
  <Words>66</Words>
  <Application>Microsoft Office PowerPoint</Application>
  <PresentationFormat>宽屏</PresentationFormat>
  <Paragraphs>20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用户</dc:creator>
  <cp:lastModifiedBy>孙 秀明</cp:lastModifiedBy>
  <cp:revision>11</cp:revision>
  <dcterms:created xsi:type="dcterms:W3CDTF">2021-07-06T13:40:44Z</dcterms:created>
  <dcterms:modified xsi:type="dcterms:W3CDTF">2021-07-07T13:04:18Z</dcterms:modified>
</cp:coreProperties>
</file>